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85C2BC0-6D86-0345-CD46-FDCB51B25A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076" y="782285"/>
            <a:ext cx="5320724" cy="5342986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5107331-D1E6-2F46-6C11-9BE453815C38}"/>
              </a:ext>
            </a:extLst>
          </p:cNvPr>
          <p:cNvSpPr txBox="1"/>
          <p:nvPr/>
        </p:nvSpPr>
        <p:spPr>
          <a:xfrm>
            <a:off x="547254" y="6154469"/>
            <a:ext cx="55331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Fig. Correlations between bioclimatic variables.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rker green indicates higher positive correlations.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1135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895</TotalTime>
  <Words>15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1</cp:revision>
  <cp:lastPrinted>2023-10-10T08:11:58Z</cp:lastPrinted>
  <dcterms:created xsi:type="dcterms:W3CDTF">2023-07-12T06:47:41Z</dcterms:created>
  <dcterms:modified xsi:type="dcterms:W3CDTF">2025-08-29T07:21:27Z</dcterms:modified>
  <cp:category/>
</cp:coreProperties>
</file>